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4" r:id="rId2"/>
  </p:sldIdLst>
  <p:sldSz cx="6858000" cy="9906000" type="A4"/>
  <p:notesSz cx="6797675" cy="9926638"/>
  <p:defaultTextStyle>
    <a:defPPr>
      <a:defRPr lang="en-US"/>
    </a:defPPr>
    <a:lvl1pPr marL="0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9"/>
    <a:srgbClr val="FFF7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1950" y="-1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Fusarium\Fom\Effector%20gene%20lists\New%20biokanga_gff\EdgeR_GOterms%20(Autosaved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Fusarium\Fom\Effector%20gene%20lists\New%20biokanga_gff\EdgeR_GOterms%20(Autosaved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fswa01-per\CSIRO\PI\Home\tha044\Fusarium\Fom\Effector%20gene%20lists\New%20biokanga_gff\EdgeR_GOterms%20(Autosaved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/>
              <a:t>Up A17 2dp</a:t>
            </a:r>
            <a:r>
              <a:rPr lang="en-US" sz="1200" baseline="0" dirty="0" smtClean="0"/>
              <a:t>i vs IV</a:t>
            </a:r>
            <a:endParaRPr 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%s'!$AM$7</c:f>
              <c:strCache>
                <c:ptCount val="1"/>
                <c:pt idx="0">
                  <c:v>%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0"/>
              <c:layout>
                <c:manualLayout>
                  <c:x val="0.17799335426915971"/>
                  <c:y val="-8.9903694207666029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8984313337844927"/>
                  <c:y val="-3.5179857616101387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.20043128816162661"/>
                  <c:y val="9.7222254419456811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4.0242409495639217E-2"/>
                  <c:y val="0.10027184769111055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-0.23004509059940842"/>
                  <c:y val="0.10304402958951617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9974816177868349"/>
                  <c:y val="3.1936308203263035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2179115372624759"/>
                  <c:y val="-4.8237896866334213E-3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16235839802909219"/>
                  <c:y val="-6.991577976164258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5271372411852821"/>
                  <c:y val="-0.26028489143478861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solidFill>
                <a:sysClr val="window" lastClr="FFFFFF"/>
              </a:solidFill>
              <a:ln>
                <a:solidFill>
                  <a:sysClr val="windowText" lastClr="000000">
                    <a:lumMod val="25000"/>
                    <a:lumOff val="75000"/>
                  </a:sysClr>
                </a:solidFill>
              </a:ln>
              <a:effectLst/>
            </c:spPr>
            <c:txPr>
              <a:bodyPr rot="0" spcFirstLastPara="1" vertOverflow="clip" horzOverflow="clip" vert="horz" wrap="square" lIns="36576" tIns="18288" rIns="36576" bIns="18288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%s'!$AL$8:$AL$43</c:f>
              <c:strCache>
                <c:ptCount val="9"/>
                <c:pt idx="0">
                  <c:v>metabolism</c:v>
                </c:pt>
                <c:pt idx="1">
                  <c:v>catalytic activity</c:v>
                </c:pt>
                <c:pt idx="2">
                  <c:v>binding</c:v>
                </c:pt>
                <c:pt idx="3">
                  <c:v>catabolism</c:v>
                </c:pt>
                <c:pt idx="4">
                  <c:v>hydrolase activity</c:v>
                </c:pt>
                <c:pt idx="5">
                  <c:v>biosynthesis</c:v>
                </c:pt>
                <c:pt idx="6">
                  <c:v>cell</c:v>
                </c:pt>
                <c:pt idx="7">
                  <c:v>carbohydrate metabolism</c:v>
                </c:pt>
                <c:pt idx="8">
                  <c:v>nucleobase, nucleoside, nucleotide and nucleic acid metabolism</c:v>
                </c:pt>
              </c:strCache>
            </c:strRef>
          </c:cat>
          <c:val>
            <c:numRef>
              <c:f>'%s'!$AM$8:$AM$43</c:f>
              <c:numCache>
                <c:formatCode>General</c:formatCode>
                <c:ptCount val="36"/>
                <c:pt idx="0">
                  <c:v>49.532710280373834</c:v>
                </c:pt>
                <c:pt idx="1">
                  <c:v>29.906542056074763</c:v>
                </c:pt>
                <c:pt idx="2">
                  <c:v>16.822429906542055</c:v>
                </c:pt>
                <c:pt idx="3">
                  <c:v>15.887850467289718</c:v>
                </c:pt>
                <c:pt idx="4">
                  <c:v>10.2803738317757</c:v>
                </c:pt>
                <c:pt idx="5">
                  <c:v>7.4766355140186906</c:v>
                </c:pt>
                <c:pt idx="6">
                  <c:v>6.5420560747663545</c:v>
                </c:pt>
                <c:pt idx="7">
                  <c:v>6.5420560747663545</c:v>
                </c:pt>
                <c:pt idx="8">
                  <c:v>5.6074766355140184</c:v>
                </c:pt>
                <c:pt idx="9">
                  <c:v>4.6728971962616823</c:v>
                </c:pt>
                <c:pt idx="10">
                  <c:v>4.6728971962616823</c:v>
                </c:pt>
                <c:pt idx="11">
                  <c:v>3.7383177570093453</c:v>
                </c:pt>
                <c:pt idx="12">
                  <c:v>3.7383177570093453</c:v>
                </c:pt>
                <c:pt idx="13">
                  <c:v>2.8037383177570092</c:v>
                </c:pt>
                <c:pt idx="14">
                  <c:v>2.8037383177570092</c:v>
                </c:pt>
                <c:pt idx="15">
                  <c:v>2.8037383177570092</c:v>
                </c:pt>
                <c:pt idx="16">
                  <c:v>1.8691588785046727</c:v>
                </c:pt>
                <c:pt idx="17">
                  <c:v>1.8691588785046727</c:v>
                </c:pt>
                <c:pt idx="18">
                  <c:v>1.8691588785046727</c:v>
                </c:pt>
                <c:pt idx="19">
                  <c:v>1.8691588785046727</c:v>
                </c:pt>
                <c:pt idx="20">
                  <c:v>1.8691588785046727</c:v>
                </c:pt>
                <c:pt idx="21">
                  <c:v>0.93457943925233633</c:v>
                </c:pt>
                <c:pt idx="22">
                  <c:v>0.93457943925233633</c:v>
                </c:pt>
                <c:pt idx="23">
                  <c:v>0.93457943925233633</c:v>
                </c:pt>
                <c:pt idx="24">
                  <c:v>0.93457943925233633</c:v>
                </c:pt>
                <c:pt idx="25">
                  <c:v>0.93457943925233633</c:v>
                </c:pt>
                <c:pt idx="26">
                  <c:v>0.93457943925233633</c:v>
                </c:pt>
                <c:pt idx="27">
                  <c:v>0.93457943925233633</c:v>
                </c:pt>
                <c:pt idx="28">
                  <c:v>0.93457943925233633</c:v>
                </c:pt>
                <c:pt idx="29">
                  <c:v>0.93457943925233633</c:v>
                </c:pt>
                <c:pt idx="30">
                  <c:v>0.93457943925233633</c:v>
                </c:pt>
                <c:pt idx="31">
                  <c:v>0.93457943925233633</c:v>
                </c:pt>
                <c:pt idx="32">
                  <c:v>0.93457943925233633</c:v>
                </c:pt>
                <c:pt idx="33">
                  <c:v>0.93457943925233633</c:v>
                </c:pt>
                <c:pt idx="34">
                  <c:v>0.93457943925233633</c:v>
                </c:pt>
                <c:pt idx="35">
                  <c:v>0.934579439252336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  <c:holeSize val="75"/>
      </c:doughnut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/>
              <a:t>Up DZA315 </a:t>
            </a:r>
            <a:r>
              <a:rPr lang="en-US" sz="1200" dirty="0"/>
              <a:t>7dpi </a:t>
            </a:r>
            <a:r>
              <a:rPr lang="en-US" sz="1200" dirty="0" smtClean="0"/>
              <a:t>vs</a:t>
            </a:r>
            <a:r>
              <a:rPr lang="en-US" sz="1200" baseline="0" dirty="0" smtClean="0"/>
              <a:t> IV</a:t>
            </a:r>
            <a:endParaRPr 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%s'!$AQ$7</c:f>
              <c:strCache>
                <c:ptCount val="1"/>
                <c:pt idx="0">
                  <c:v>%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5"/>
            <c:bubble3D val="0"/>
            <c:spPr>
              <a:solidFill>
                <a:schemeClr val="accent4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6"/>
            <c:bubble3D val="0"/>
            <c:spPr>
              <a:solidFill>
                <a:schemeClr val="accent5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7"/>
            <c:bubble3D val="0"/>
            <c:spPr>
              <a:solidFill>
                <a:schemeClr val="accent6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8"/>
            <c:bubble3D val="0"/>
            <c:spPr>
              <a:solidFill>
                <a:schemeClr val="accent1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9"/>
            <c:bubble3D val="0"/>
            <c:spPr>
              <a:solidFill>
                <a:schemeClr val="accent2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0"/>
            <c:bubble3D val="0"/>
            <c:spPr>
              <a:solidFill>
                <a:schemeClr val="accent3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1"/>
            <c:bubble3D val="0"/>
            <c:spPr>
              <a:solidFill>
                <a:schemeClr val="accent4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2"/>
            <c:bubble3D val="0"/>
            <c:spPr>
              <a:solidFill>
                <a:schemeClr val="accent5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3"/>
            <c:bubble3D val="0"/>
            <c:spPr>
              <a:solidFill>
                <a:schemeClr val="accent6">
                  <a:lumMod val="50000"/>
                  <a:lumOff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4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5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6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7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8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9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0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1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2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3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4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5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6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7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8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0"/>
              <c:layout>
                <c:manualLayout>
                  <c:x val="0.11666666666666657"/>
                  <c:y val="-9.7222222222222238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5000000000000011"/>
                  <c:y val="-4.1666666666666664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.24839187000524648"/>
                  <c:y val="2.9661380395901446E-3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.27503896953152918"/>
                  <c:y val="4.407865810168711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7.9770973211773677E-2"/>
                  <c:y val="0.10600089482554378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30106924790705103"/>
                      <c:h val="6.1967828008039523E-2"/>
                    </c:manualLayout>
                  </c15:layout>
                </c:ext>
              </c:extLst>
            </c:dLbl>
            <c:dLbl>
              <c:idx val="5"/>
              <c:layout>
                <c:manualLayout>
                  <c:x val="-0.11705884589356186"/>
                  <c:y val="0.10185170159809043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28240523750503754"/>
                  <c:y val="5.461294931562756E-3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2012156973074905"/>
                  <c:y val="-0.1764803837704301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20437127888497714"/>
                  <c:y val="-0.29241515577923616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solidFill>
                <a:sysClr val="window" lastClr="FFFFFF"/>
              </a:solidFill>
              <a:ln>
                <a:solidFill>
                  <a:sysClr val="windowText" lastClr="000000">
                    <a:lumMod val="25000"/>
                    <a:lumOff val="75000"/>
                  </a:sysClr>
                </a:solidFill>
              </a:ln>
              <a:effectLst/>
            </c:spPr>
            <c:txPr>
              <a:bodyPr rot="0" spcFirstLastPara="1" vertOverflow="clip" horzOverflow="clip" vert="horz" wrap="square" lIns="36576" tIns="18288" rIns="36576" bIns="18288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%s'!$AP$8:$AP$76</c:f>
              <c:strCache>
                <c:ptCount val="9"/>
                <c:pt idx="0">
                  <c:v>metabolism</c:v>
                </c:pt>
                <c:pt idx="1">
                  <c:v>catalytic activity</c:v>
                </c:pt>
                <c:pt idx="2">
                  <c:v>binding</c:v>
                </c:pt>
                <c:pt idx="3">
                  <c:v>biosynthesis</c:v>
                </c:pt>
                <c:pt idx="4">
                  <c:v>hydrolase activity</c:v>
                </c:pt>
                <c:pt idx="5">
                  <c:v>catabolism</c:v>
                </c:pt>
                <c:pt idx="6">
                  <c:v>nucleobase, nucleoside, nucleotide and nucleic acid metabolism</c:v>
                </c:pt>
                <c:pt idx="7">
                  <c:v>cell</c:v>
                </c:pt>
                <c:pt idx="8">
                  <c:v>carbohydrate metabolism</c:v>
                </c:pt>
              </c:strCache>
            </c:strRef>
          </c:cat>
          <c:val>
            <c:numRef>
              <c:f>'%s'!$AQ$8:$AQ$76</c:f>
              <c:numCache>
                <c:formatCode>General</c:formatCode>
                <c:ptCount val="69"/>
                <c:pt idx="0">
                  <c:v>33.183856502242151</c:v>
                </c:pt>
                <c:pt idx="1">
                  <c:v>26.905829596412556</c:v>
                </c:pt>
                <c:pt idx="2">
                  <c:v>9.6412556053811667</c:v>
                </c:pt>
                <c:pt idx="3">
                  <c:v>9.4170403587443943</c:v>
                </c:pt>
                <c:pt idx="4">
                  <c:v>8.7443946188340806</c:v>
                </c:pt>
                <c:pt idx="5">
                  <c:v>8.2959641255605376</c:v>
                </c:pt>
                <c:pt idx="6">
                  <c:v>6.5022421524663674</c:v>
                </c:pt>
                <c:pt idx="7">
                  <c:v>5.8295964125560538</c:v>
                </c:pt>
                <c:pt idx="8">
                  <c:v>4.9327354260089686</c:v>
                </c:pt>
                <c:pt idx="9">
                  <c:v>4.7085201793721971</c:v>
                </c:pt>
                <c:pt idx="10">
                  <c:v>4.7085201793721971</c:v>
                </c:pt>
                <c:pt idx="11">
                  <c:v>3.3632286995515694</c:v>
                </c:pt>
                <c:pt idx="12">
                  <c:v>3.1390134529147984</c:v>
                </c:pt>
                <c:pt idx="13">
                  <c:v>2.9147982062780269</c:v>
                </c:pt>
                <c:pt idx="14">
                  <c:v>2.9147982062780269</c:v>
                </c:pt>
                <c:pt idx="15">
                  <c:v>2.6905829596412558</c:v>
                </c:pt>
                <c:pt idx="16">
                  <c:v>2.0179372197309418</c:v>
                </c:pt>
                <c:pt idx="17">
                  <c:v>1.7937219730941705</c:v>
                </c:pt>
                <c:pt idx="18">
                  <c:v>1.7937219730941705</c:v>
                </c:pt>
                <c:pt idx="19">
                  <c:v>1.5695067264573992</c:v>
                </c:pt>
                <c:pt idx="20">
                  <c:v>1.3452914798206279</c:v>
                </c:pt>
                <c:pt idx="21">
                  <c:v>1.3452914798206279</c:v>
                </c:pt>
                <c:pt idx="22">
                  <c:v>1.1210762331838564</c:v>
                </c:pt>
                <c:pt idx="23">
                  <c:v>1.1210762331838564</c:v>
                </c:pt>
                <c:pt idx="24">
                  <c:v>1.1210762331838564</c:v>
                </c:pt>
                <c:pt idx="25">
                  <c:v>1.1210762331838564</c:v>
                </c:pt>
                <c:pt idx="26">
                  <c:v>1.1210762331838564</c:v>
                </c:pt>
                <c:pt idx="27">
                  <c:v>1.1210762331838564</c:v>
                </c:pt>
                <c:pt idx="28">
                  <c:v>1.1210762331838564</c:v>
                </c:pt>
                <c:pt idx="29">
                  <c:v>0.89686098654708524</c:v>
                </c:pt>
                <c:pt idx="30">
                  <c:v>0.89686098654708524</c:v>
                </c:pt>
                <c:pt idx="31">
                  <c:v>0.89686098654708524</c:v>
                </c:pt>
                <c:pt idx="32">
                  <c:v>0.67264573991031396</c:v>
                </c:pt>
                <c:pt idx="33">
                  <c:v>0.67264573991031396</c:v>
                </c:pt>
                <c:pt idx="34">
                  <c:v>0.67264573991031396</c:v>
                </c:pt>
                <c:pt idx="35">
                  <c:v>0.67264573991031396</c:v>
                </c:pt>
                <c:pt idx="36">
                  <c:v>0.44843049327354262</c:v>
                </c:pt>
                <c:pt idx="37">
                  <c:v>0.44843049327354262</c:v>
                </c:pt>
                <c:pt idx="38">
                  <c:v>0.44843049327354262</c:v>
                </c:pt>
                <c:pt idx="39">
                  <c:v>0.44843049327354262</c:v>
                </c:pt>
                <c:pt idx="40">
                  <c:v>0.44843049327354262</c:v>
                </c:pt>
                <c:pt idx="41">
                  <c:v>0.44843049327354262</c:v>
                </c:pt>
                <c:pt idx="42">
                  <c:v>0.44843049327354262</c:v>
                </c:pt>
                <c:pt idx="43">
                  <c:v>0.44843049327354262</c:v>
                </c:pt>
                <c:pt idx="44">
                  <c:v>0.44843049327354262</c:v>
                </c:pt>
                <c:pt idx="45">
                  <c:v>0.44843049327354262</c:v>
                </c:pt>
                <c:pt idx="46">
                  <c:v>0.44843049327354262</c:v>
                </c:pt>
                <c:pt idx="47">
                  <c:v>0.44843049327354262</c:v>
                </c:pt>
                <c:pt idx="48">
                  <c:v>0.44843049327354262</c:v>
                </c:pt>
                <c:pt idx="49">
                  <c:v>0.22421524663677131</c:v>
                </c:pt>
                <c:pt idx="50">
                  <c:v>0.22421524663677131</c:v>
                </c:pt>
                <c:pt idx="51">
                  <c:v>0.22421524663677131</c:v>
                </c:pt>
                <c:pt idx="52">
                  <c:v>0.22421524663677131</c:v>
                </c:pt>
                <c:pt idx="53">
                  <c:v>0.22421524663677131</c:v>
                </c:pt>
                <c:pt idx="54">
                  <c:v>0.22421524663677131</c:v>
                </c:pt>
                <c:pt idx="55">
                  <c:v>0.22421524663677131</c:v>
                </c:pt>
                <c:pt idx="56">
                  <c:v>0.22421524663677131</c:v>
                </c:pt>
                <c:pt idx="57">
                  <c:v>0.22421524663677131</c:v>
                </c:pt>
                <c:pt idx="58">
                  <c:v>0.22421524663677131</c:v>
                </c:pt>
                <c:pt idx="59">
                  <c:v>0.22421524663677131</c:v>
                </c:pt>
                <c:pt idx="60">
                  <c:v>0.22421524663677131</c:v>
                </c:pt>
                <c:pt idx="61">
                  <c:v>0.22421524663677131</c:v>
                </c:pt>
                <c:pt idx="62">
                  <c:v>0.22421524663677131</c:v>
                </c:pt>
                <c:pt idx="63">
                  <c:v>0.22421524663677131</c:v>
                </c:pt>
                <c:pt idx="64">
                  <c:v>0.22421524663677131</c:v>
                </c:pt>
                <c:pt idx="65">
                  <c:v>0.22421524663677131</c:v>
                </c:pt>
                <c:pt idx="66">
                  <c:v>0.22421524663677131</c:v>
                </c:pt>
                <c:pt idx="67">
                  <c:v>0.22421524663677131</c:v>
                </c:pt>
                <c:pt idx="68">
                  <c:v>0.224215246636771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  <c:holeSize val="75"/>
      </c:doughnut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/>
              <a:t>Up A17 7dpi</a:t>
            </a:r>
            <a:r>
              <a:rPr lang="en-US" sz="1200" baseline="0" dirty="0" smtClean="0"/>
              <a:t> vs IV</a:t>
            </a:r>
            <a:endParaRPr lang="en-US" sz="1200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%s'!$AU$7</c:f>
              <c:strCache>
                <c:ptCount val="1"/>
                <c:pt idx="0">
                  <c:v>%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3"/>
            <c:bubble3D val="0"/>
            <c:spPr>
              <a:solidFill>
                <a:schemeClr val="accent4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4"/>
            <c:bubble3D val="0"/>
            <c:spPr>
              <a:solidFill>
                <a:schemeClr val="accent5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5"/>
            <c:bubble3D val="0"/>
            <c:spPr>
              <a:solidFill>
                <a:schemeClr val="accent6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6"/>
            <c:bubble3D val="0"/>
            <c:spPr>
              <a:solidFill>
                <a:schemeClr val="accent1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7"/>
            <c:bubble3D val="0"/>
            <c:spPr>
              <a:solidFill>
                <a:schemeClr val="accent2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8"/>
            <c:bubble3D val="0"/>
            <c:spPr>
              <a:solidFill>
                <a:schemeClr val="accent3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9"/>
            <c:bubble3D val="0"/>
            <c:spPr>
              <a:solidFill>
                <a:schemeClr val="accent4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0"/>
            <c:bubble3D val="0"/>
            <c:spPr>
              <a:solidFill>
                <a:schemeClr val="accent5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1"/>
            <c:bubble3D val="0"/>
            <c:spPr>
              <a:solidFill>
                <a:schemeClr val="accent6">
                  <a:lumMod val="70000"/>
                  <a:lumOff val="3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2"/>
            <c:bubble3D val="0"/>
            <c:spPr>
              <a:solidFill>
                <a:schemeClr val="accent1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3"/>
            <c:bubble3D val="0"/>
            <c:spPr>
              <a:solidFill>
                <a:schemeClr val="accent2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4"/>
            <c:bubble3D val="0"/>
            <c:spPr>
              <a:solidFill>
                <a:schemeClr val="accent3">
                  <a:lumMod val="7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0"/>
              <c:layout>
                <c:manualLayout>
                  <c:x val="0.15833333333333324"/>
                  <c:y val="-7.4074074074074112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388888888888889"/>
                  <c:y val="-1.8518518518518517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.18571882627572939"/>
                  <c:y val="4.166657007496289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.25524837848729787"/>
                  <c:y val="8.0325081310896246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8561830389391163"/>
                      <c:h val="7.6688403663684679E-2"/>
                    </c:manualLayout>
                  </c15:layout>
                </c:ext>
              </c:extLst>
            </c:dLbl>
            <c:dLbl>
              <c:idx val="4"/>
              <c:layout>
                <c:manualLayout>
                  <c:x val="-8.0555686510078814E-2"/>
                  <c:y val="9.6856751412363898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0.17126793548926722"/>
                  <c:y val="8.9349257827984682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22960133218769246"/>
                  <c:y val="3.3516162110242727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0.20943876270786918"/>
                  <c:y val="-3.0743980211837288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8318006584900351"/>
                  <c:y val="-0.11407750672857808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solidFill>
                <a:sysClr val="window" lastClr="FFFFFF"/>
              </a:solidFill>
              <a:ln>
                <a:solidFill>
                  <a:sysClr val="windowText" lastClr="000000">
                    <a:lumMod val="25000"/>
                    <a:lumOff val="75000"/>
                  </a:sysClr>
                </a:solidFill>
              </a:ln>
              <a:effectLst/>
            </c:spPr>
            <c:txPr>
              <a:bodyPr rot="0" spcFirstLastPara="1" vertOverflow="clip" horzOverflow="clip" vert="horz" wrap="square" lIns="36576" tIns="18288" rIns="36576" bIns="18288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%s'!$AT$8:$AT$52</c:f>
              <c:strCache>
                <c:ptCount val="9"/>
                <c:pt idx="0">
                  <c:v>metabolism</c:v>
                </c:pt>
                <c:pt idx="1">
                  <c:v>catalytic activity</c:v>
                </c:pt>
                <c:pt idx="2">
                  <c:v>binding</c:v>
                </c:pt>
                <c:pt idx="3">
                  <c:v>hydrolase activity</c:v>
                </c:pt>
                <c:pt idx="4">
                  <c:v>catabolism</c:v>
                </c:pt>
                <c:pt idx="5">
                  <c:v>cell</c:v>
                </c:pt>
                <c:pt idx="6">
                  <c:v>biosynthesis</c:v>
                </c:pt>
                <c:pt idx="7">
                  <c:v>intracellular</c:v>
                </c:pt>
                <c:pt idx="8">
                  <c:v>carbohydrate metabolism</c:v>
                </c:pt>
              </c:strCache>
            </c:strRef>
          </c:cat>
          <c:val>
            <c:numRef>
              <c:f>'%s'!$AU$8:$AU$52</c:f>
              <c:numCache>
                <c:formatCode>General</c:formatCode>
                <c:ptCount val="45"/>
                <c:pt idx="0">
                  <c:v>32.03125</c:v>
                </c:pt>
                <c:pt idx="1">
                  <c:v>28.90625</c:v>
                </c:pt>
                <c:pt idx="2">
                  <c:v>17.96875</c:v>
                </c:pt>
                <c:pt idx="3">
                  <c:v>14.0625</c:v>
                </c:pt>
                <c:pt idx="4">
                  <c:v>7.8125</c:v>
                </c:pt>
                <c:pt idx="5">
                  <c:v>7.03125</c:v>
                </c:pt>
                <c:pt idx="6">
                  <c:v>5.46875</c:v>
                </c:pt>
                <c:pt idx="7">
                  <c:v>5.46875</c:v>
                </c:pt>
                <c:pt idx="8">
                  <c:v>5.46875</c:v>
                </c:pt>
                <c:pt idx="9">
                  <c:v>4.6875</c:v>
                </c:pt>
                <c:pt idx="10">
                  <c:v>3.90625</c:v>
                </c:pt>
                <c:pt idx="11">
                  <c:v>3.90625</c:v>
                </c:pt>
                <c:pt idx="12">
                  <c:v>3.125</c:v>
                </c:pt>
                <c:pt idx="13">
                  <c:v>3.125</c:v>
                </c:pt>
                <c:pt idx="14">
                  <c:v>3.125</c:v>
                </c:pt>
                <c:pt idx="15">
                  <c:v>3.125</c:v>
                </c:pt>
                <c:pt idx="16">
                  <c:v>2.34375</c:v>
                </c:pt>
                <c:pt idx="17">
                  <c:v>2.34375</c:v>
                </c:pt>
                <c:pt idx="18">
                  <c:v>2.34375</c:v>
                </c:pt>
                <c:pt idx="19">
                  <c:v>1.5625</c:v>
                </c:pt>
                <c:pt idx="20">
                  <c:v>1.5625</c:v>
                </c:pt>
                <c:pt idx="21">
                  <c:v>1.5625</c:v>
                </c:pt>
                <c:pt idx="22">
                  <c:v>1.5625</c:v>
                </c:pt>
                <c:pt idx="23">
                  <c:v>1.5625</c:v>
                </c:pt>
                <c:pt idx="24">
                  <c:v>1.5625</c:v>
                </c:pt>
                <c:pt idx="25">
                  <c:v>0.78125</c:v>
                </c:pt>
                <c:pt idx="26">
                  <c:v>0.78125</c:v>
                </c:pt>
                <c:pt idx="27">
                  <c:v>0.78125</c:v>
                </c:pt>
                <c:pt idx="28">
                  <c:v>0.78125</c:v>
                </c:pt>
                <c:pt idx="29">
                  <c:v>0.78125</c:v>
                </c:pt>
                <c:pt idx="30">
                  <c:v>0.78125</c:v>
                </c:pt>
                <c:pt idx="31">
                  <c:v>0.78125</c:v>
                </c:pt>
                <c:pt idx="32">
                  <c:v>0.78125</c:v>
                </c:pt>
                <c:pt idx="33">
                  <c:v>0.78125</c:v>
                </c:pt>
                <c:pt idx="34">
                  <c:v>0.78125</c:v>
                </c:pt>
                <c:pt idx="35">
                  <c:v>0.78125</c:v>
                </c:pt>
                <c:pt idx="36">
                  <c:v>0.78125</c:v>
                </c:pt>
                <c:pt idx="37">
                  <c:v>0.78125</c:v>
                </c:pt>
                <c:pt idx="38">
                  <c:v>0.78125</c:v>
                </c:pt>
                <c:pt idx="39">
                  <c:v>0.78125</c:v>
                </c:pt>
                <c:pt idx="40">
                  <c:v>0.78125</c:v>
                </c:pt>
                <c:pt idx="41">
                  <c:v>0.78125</c:v>
                </c:pt>
                <c:pt idx="42">
                  <c:v>0.78125</c:v>
                </c:pt>
                <c:pt idx="43">
                  <c:v>0.78125</c:v>
                </c:pt>
                <c:pt idx="44">
                  <c:v>0.781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  <c:holeSize val="75"/>
      </c:doughnut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 smtClean="0"/>
              <a:t>Up </a:t>
            </a:r>
            <a:r>
              <a:rPr lang="en-US" sz="1200" dirty="0"/>
              <a:t>DZA315 2dpi vs IV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%s'!$AU$7</c:f>
              <c:strCache>
                <c:ptCount val="1"/>
                <c:pt idx="0">
                  <c:v>%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4"/>
            <c:bubble3D val="0"/>
            <c:spPr>
              <a:solidFill>
                <a:schemeClr val="accent3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5"/>
            <c:bubble3D val="0"/>
            <c:spPr>
              <a:solidFill>
                <a:schemeClr val="accent4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6"/>
            <c:bubble3D val="0"/>
            <c:spPr>
              <a:solidFill>
                <a:schemeClr val="accent5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7"/>
            <c:bubble3D val="0"/>
            <c:spPr>
              <a:solidFill>
                <a:schemeClr val="accent6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8"/>
            <c:bubble3D val="0"/>
            <c:spPr>
              <a:solidFill>
                <a:schemeClr val="accent1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19"/>
            <c:bubble3D val="0"/>
            <c:spPr>
              <a:solidFill>
                <a:schemeClr val="accent2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0"/>
            <c:bubble3D val="0"/>
            <c:spPr>
              <a:solidFill>
                <a:schemeClr val="accent3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1"/>
            <c:bubble3D val="0"/>
            <c:spPr>
              <a:solidFill>
                <a:schemeClr val="accent4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2"/>
            <c:bubble3D val="0"/>
            <c:spPr>
              <a:solidFill>
                <a:schemeClr val="accent5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3"/>
            <c:bubble3D val="0"/>
            <c:spPr>
              <a:solidFill>
                <a:schemeClr val="accent6">
                  <a:lumMod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4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5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6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7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8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29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0"/>
            <c:bubble3D val="0"/>
            <c:spPr>
              <a:solidFill>
                <a:schemeClr val="accent1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1"/>
            <c:bubble3D val="0"/>
            <c:spPr>
              <a:solidFill>
                <a:schemeClr val="accent2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Pt>
            <c:idx val="32"/>
            <c:bubble3D val="0"/>
            <c:spPr>
              <a:solidFill>
                <a:schemeClr val="accent3">
                  <a:lumMod val="5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</c:dPt>
          <c:dLbls>
            <c:dLbl>
              <c:idx val="0"/>
              <c:layout>
                <c:manualLayout>
                  <c:x val="0.18749999999999989"/>
                  <c:y val="-7.407407407407407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8154761904761904"/>
                  <c:y val="9.2592592592591737E-3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.13988095238095238"/>
                  <c:y val="9.7222222222222224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-5.7288406006416319E-2"/>
                  <c:y val="0.10010551631775108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4467627347199327"/>
                      <c:h val="8.1110617123308915E-2"/>
                    </c:manualLayout>
                  </c15:layout>
                </c:ext>
              </c:extLst>
            </c:dLbl>
            <c:dLbl>
              <c:idx val="4"/>
              <c:layout>
                <c:manualLayout>
                  <c:x val="-0.18800562358154413"/>
                  <c:y val="0.13486311720080768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917153827922974"/>
                      <c:h val="0.1158148516277334"/>
                    </c:manualLayout>
                  </c15:layout>
                </c:ext>
              </c:extLst>
            </c:dLbl>
            <c:dLbl>
              <c:idx val="5"/>
              <c:layout>
                <c:manualLayout>
                  <c:x val="-0.21348897885239213"/>
                  <c:y val="9.5777346050750736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0.1737582990745816"/>
                  <c:y val="1.6719764905406134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1572833378692671"/>
                      <c:h val="0.12052521934170217"/>
                    </c:manualLayout>
                  </c15:layout>
                </c:ext>
              </c:extLst>
            </c:dLbl>
            <c:dLbl>
              <c:idx val="7"/>
              <c:layout>
                <c:manualLayout>
                  <c:x val="-0.16369047619047619"/>
                  <c:y val="-9.2592592592592587E-2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0.17566573496923815"/>
                  <c:y val="-0.26032080256755064"/>
                </c:manualLayout>
              </c:layout>
              <c:showLegendKey val="0"/>
              <c:showVal val="0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4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5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6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7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8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19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2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3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4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5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6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7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8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29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0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1"/>
              <c:delete val="1"/>
              <c:extLst>
                <c:ext xmlns:c15="http://schemas.microsoft.com/office/drawing/2012/chart" uri="{CE6537A1-D6FC-4f65-9D91-7224C49458BB}"/>
              </c:extLst>
            </c:dLbl>
            <c:dLbl>
              <c:idx val="32"/>
              <c:delete val="1"/>
              <c:extLst>
                <c:ext xmlns:c15="http://schemas.microsoft.com/office/drawing/2012/chart" uri="{CE6537A1-D6FC-4f65-9D91-7224C49458BB}"/>
              </c:extLst>
            </c:dLbl>
            <c:spPr>
              <a:solidFill>
                <a:sysClr val="window" lastClr="FFFFFF"/>
              </a:solidFill>
              <a:ln>
                <a:solidFill>
                  <a:sysClr val="windowText" lastClr="000000">
                    <a:lumMod val="25000"/>
                    <a:lumOff val="75000"/>
                  </a:sysClr>
                </a:solidFill>
              </a:ln>
              <a:effectLst/>
            </c:spPr>
            <c:txPr>
              <a:bodyPr rot="0" spcFirstLastPara="1" vertOverflow="clip" horzOverflow="clip" vert="horz" wrap="square" lIns="36576" tIns="18288" rIns="36576" bIns="18288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</c:ext>
            </c:extLst>
          </c:dLbls>
          <c:cat>
            <c:strRef>
              <c:f>'%s'!$AT$8:$AT$40</c:f>
              <c:strCache>
                <c:ptCount val="33"/>
                <c:pt idx="0">
                  <c:v>metabolism</c:v>
                </c:pt>
                <c:pt idx="1">
                  <c:v>catalytic activity</c:v>
                </c:pt>
                <c:pt idx="2">
                  <c:v>catabolism</c:v>
                </c:pt>
                <c:pt idx="3">
                  <c:v>binding</c:v>
                </c:pt>
                <c:pt idx="4">
                  <c:v>hydrolase activity</c:v>
                </c:pt>
                <c:pt idx="5">
                  <c:v>biosynthesis</c:v>
                </c:pt>
                <c:pt idx="6">
                  <c:v>carbohydrate metabolism</c:v>
                </c:pt>
                <c:pt idx="7">
                  <c:v>cell</c:v>
                </c:pt>
                <c:pt idx="8">
                  <c:v>nucleobase, nucleoside, nucleotide and nucleic acid metabolism</c:v>
                </c:pt>
                <c:pt idx="9">
                  <c:v>transferase activity</c:v>
                </c:pt>
                <c:pt idx="10">
                  <c:v>peptidase activity</c:v>
                </c:pt>
                <c:pt idx="11">
                  <c:v>intracellular</c:v>
                </c:pt>
                <c:pt idx="12">
                  <c:v>lipid metabolism</c:v>
                </c:pt>
                <c:pt idx="13">
                  <c:v>cytoplasm</c:v>
                </c:pt>
                <c:pt idx="14">
                  <c:v>transporter activity</c:v>
                </c:pt>
                <c:pt idx="15">
                  <c:v>nucleotide binding</c:v>
                </c:pt>
                <c:pt idx="16">
                  <c:v>transcription factor activity</c:v>
                </c:pt>
                <c:pt idx="17">
                  <c:v>protein metabolism</c:v>
                </c:pt>
                <c:pt idx="18">
                  <c:v>DNA binding</c:v>
                </c:pt>
                <c:pt idx="19">
                  <c:v>transport</c:v>
                </c:pt>
                <c:pt idx="20">
                  <c:v>nucleic acid binding</c:v>
                </c:pt>
                <c:pt idx="21">
                  <c:v>cell organization and biogenesis</c:v>
                </c:pt>
                <c:pt idx="22">
                  <c:v>external encapsulating structure</c:v>
                </c:pt>
                <c:pt idx="23">
                  <c:v>electron transport</c:v>
                </c:pt>
                <c:pt idx="24">
                  <c:v>generation of precursor metabolites and energy</c:v>
                </c:pt>
                <c:pt idx="25">
                  <c:v>development</c:v>
                </c:pt>
                <c:pt idx="26">
                  <c:v>antioxidant activity</c:v>
                </c:pt>
                <c:pt idx="27">
                  <c:v>cytosol</c:v>
                </c:pt>
                <c:pt idx="28">
                  <c:v>extracellular region</c:v>
                </c:pt>
                <c:pt idx="29">
                  <c:v>mitochondrion</c:v>
                </c:pt>
                <c:pt idx="30">
                  <c:v>nucleus</c:v>
                </c:pt>
                <c:pt idx="31">
                  <c:v>ion transport</c:v>
                </c:pt>
                <c:pt idx="32">
                  <c:v>cell wall</c:v>
                </c:pt>
              </c:strCache>
            </c:strRef>
          </c:cat>
          <c:val>
            <c:numRef>
              <c:f>'%s'!$AU$8:$AU$40</c:f>
              <c:numCache>
                <c:formatCode>General</c:formatCode>
                <c:ptCount val="33"/>
                <c:pt idx="0">
                  <c:v>47.863247863247864</c:v>
                </c:pt>
                <c:pt idx="1">
                  <c:v>30.76923076923077</c:v>
                </c:pt>
                <c:pt idx="2">
                  <c:v>16.239316239316238</c:v>
                </c:pt>
                <c:pt idx="3">
                  <c:v>12.820512820512819</c:v>
                </c:pt>
                <c:pt idx="4">
                  <c:v>10.256410256410255</c:v>
                </c:pt>
                <c:pt idx="5">
                  <c:v>8.5470085470085468</c:v>
                </c:pt>
                <c:pt idx="6">
                  <c:v>5.982905982905983</c:v>
                </c:pt>
                <c:pt idx="7">
                  <c:v>5.1282051282051277</c:v>
                </c:pt>
                <c:pt idx="8">
                  <c:v>5.1282051282051277</c:v>
                </c:pt>
                <c:pt idx="9">
                  <c:v>5.1282051282051277</c:v>
                </c:pt>
                <c:pt idx="10">
                  <c:v>4.2735042735042734</c:v>
                </c:pt>
                <c:pt idx="11">
                  <c:v>4.2735042735042734</c:v>
                </c:pt>
                <c:pt idx="12">
                  <c:v>3.4188034188034191</c:v>
                </c:pt>
                <c:pt idx="13">
                  <c:v>2.5641025641025639</c:v>
                </c:pt>
                <c:pt idx="14">
                  <c:v>2.5641025641025639</c:v>
                </c:pt>
                <c:pt idx="15">
                  <c:v>2.5641025641025639</c:v>
                </c:pt>
                <c:pt idx="16">
                  <c:v>1.7094017094017095</c:v>
                </c:pt>
                <c:pt idx="17">
                  <c:v>1.7094017094017095</c:v>
                </c:pt>
                <c:pt idx="18">
                  <c:v>1.7094017094017095</c:v>
                </c:pt>
                <c:pt idx="19">
                  <c:v>1.7094017094017095</c:v>
                </c:pt>
                <c:pt idx="20">
                  <c:v>1.7094017094017095</c:v>
                </c:pt>
                <c:pt idx="21">
                  <c:v>0.85470085470085477</c:v>
                </c:pt>
                <c:pt idx="22">
                  <c:v>0.85470085470085477</c:v>
                </c:pt>
                <c:pt idx="23">
                  <c:v>0.85470085470085477</c:v>
                </c:pt>
                <c:pt idx="24">
                  <c:v>0.85470085470085477</c:v>
                </c:pt>
                <c:pt idx="25">
                  <c:v>0.85470085470085477</c:v>
                </c:pt>
                <c:pt idx="26">
                  <c:v>0.85470085470085477</c:v>
                </c:pt>
                <c:pt idx="27">
                  <c:v>0.85470085470085477</c:v>
                </c:pt>
                <c:pt idx="28">
                  <c:v>0.85470085470085477</c:v>
                </c:pt>
                <c:pt idx="29">
                  <c:v>0.85470085470085477</c:v>
                </c:pt>
                <c:pt idx="30">
                  <c:v>0.85470085470085477</c:v>
                </c:pt>
                <c:pt idx="31">
                  <c:v>0.85470085470085477</c:v>
                </c:pt>
                <c:pt idx="32">
                  <c:v>0.854700854700854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firstSliceAng val="0"/>
        <c:holeSize val="75"/>
      </c:doughnut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57227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4813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42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5524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0004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636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3589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296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031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3487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928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BA8CA-4CF0-4E11-93E7-4864458BAA90}" type="datetimeFigureOut">
              <a:rPr lang="en-AU" smtClean="0"/>
              <a:t>11/06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233A6-A5B4-4EB3-BBD4-1A5BAC327B2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1826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7169875"/>
              </p:ext>
            </p:extLst>
          </p:nvPr>
        </p:nvGraphicFramePr>
        <p:xfrm>
          <a:off x="121914" y="766352"/>
          <a:ext cx="3287825" cy="2588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09737655"/>
              </p:ext>
            </p:extLst>
          </p:nvPr>
        </p:nvGraphicFramePr>
        <p:xfrm>
          <a:off x="3609702" y="3636147"/>
          <a:ext cx="3287825" cy="2588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7448363"/>
              </p:ext>
            </p:extLst>
          </p:nvPr>
        </p:nvGraphicFramePr>
        <p:xfrm>
          <a:off x="167840" y="3636147"/>
          <a:ext cx="3287825" cy="2588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34347" y="6591303"/>
            <a:ext cx="66033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200" b="1" dirty="0" smtClean="0">
                <a:cs typeface="Arial" panose="020B0604020202020204" pitchFamily="34" charset="0"/>
              </a:rPr>
              <a:t>Additional file 4. </a:t>
            </a:r>
            <a:r>
              <a:rPr lang="en-AU" sz="1200" b="1" dirty="0" smtClean="0">
                <a:cs typeface="Arial" panose="020B0604020202020204" pitchFamily="34" charset="0"/>
              </a:rPr>
              <a:t>Proportion of </a:t>
            </a:r>
            <a:r>
              <a:rPr lang="en-AU" sz="1200" b="1" i="1" dirty="0" err="1" smtClean="0">
                <a:cs typeface="Arial" panose="020B0604020202020204" pitchFamily="34" charset="0"/>
              </a:rPr>
              <a:t>Fom</a:t>
            </a:r>
            <a:r>
              <a:rPr lang="en-AU" sz="1200" b="1" dirty="0" smtClean="0">
                <a:cs typeface="Arial" panose="020B0604020202020204" pitchFamily="34" charset="0"/>
              </a:rPr>
              <a:t> proteins in A17 and DZA315 DEGs </a:t>
            </a:r>
            <a:r>
              <a:rPr lang="en-AU" sz="1200" b="1" i="1" dirty="0" smtClean="0">
                <a:cs typeface="Arial" panose="020B0604020202020204" pitchFamily="34" charset="0"/>
              </a:rPr>
              <a:t>in planta </a:t>
            </a:r>
            <a:r>
              <a:rPr lang="en-AU" sz="1200" b="1" dirty="0" smtClean="0">
                <a:cs typeface="Arial" panose="020B0604020202020204" pitchFamily="34" charset="0"/>
              </a:rPr>
              <a:t>up-regulated datasets with Gene Ontology (GO) assignments. </a:t>
            </a:r>
            <a:r>
              <a:rPr lang="en-AU" sz="1200" dirty="0" smtClean="0">
                <a:cs typeface="Arial" panose="020B0604020202020204" pitchFamily="34" charset="0"/>
              </a:rPr>
              <a:t>A-B) Percentage of proteins with GO term representation in A) 2 dpi and B) 7 dpi vs </a:t>
            </a:r>
            <a:r>
              <a:rPr lang="en-AU" sz="1200" i="1" dirty="0" smtClean="0">
                <a:cs typeface="Arial" panose="020B0604020202020204" pitchFamily="34" charset="0"/>
              </a:rPr>
              <a:t>in vitro </a:t>
            </a:r>
            <a:r>
              <a:rPr lang="en-AU" sz="1200" dirty="0" smtClean="0">
                <a:cs typeface="Arial" panose="020B0604020202020204" pitchFamily="34" charset="0"/>
              </a:rPr>
              <a:t>datasets. Only those with &gt; 5% representation from the entire DEG datasets are labelled</a:t>
            </a:r>
            <a:r>
              <a:rPr lang="en-AU" sz="1200" dirty="0">
                <a:cs typeface="Arial" panose="020B0604020202020204" pitchFamily="34" charset="0"/>
              </a:rPr>
              <a:t>. </a:t>
            </a:r>
            <a:r>
              <a:rPr lang="en-AU" sz="1200" dirty="0" smtClean="0">
                <a:cs typeface="Arial" panose="020B0604020202020204" pitchFamily="34" charset="0"/>
              </a:rPr>
              <a:t>All </a:t>
            </a:r>
            <a:r>
              <a:rPr lang="en-AU" sz="1200" dirty="0">
                <a:cs typeface="Arial" panose="020B0604020202020204" pitchFamily="34" charset="0"/>
              </a:rPr>
              <a:t>annotated GO terms are listed in </a:t>
            </a:r>
            <a:r>
              <a:rPr lang="en-AU" sz="1200" dirty="0" smtClean="0">
                <a:cs typeface="Arial" panose="020B0604020202020204" pitchFamily="34" charset="0"/>
              </a:rPr>
              <a:t>Additional file </a:t>
            </a:r>
            <a:r>
              <a:rPr lang="en-AU" sz="1200" smtClean="0">
                <a:cs typeface="Arial" panose="020B0604020202020204" pitchFamily="34" charset="0"/>
              </a:rPr>
              <a:t>5.</a:t>
            </a:r>
            <a:endParaRPr lang="en-AU" sz="1200" dirty="0" smtClean="0"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4347" y="796300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A</a:t>
            </a:r>
            <a:endParaRPr lang="en-AU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42363" y="3703933"/>
            <a:ext cx="297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/>
              <a:t>B</a:t>
            </a:r>
            <a:endParaRPr lang="en-AU" sz="1200" b="1" dirty="0"/>
          </a:p>
        </p:txBody>
      </p:sp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580299"/>
              </p:ext>
            </p:extLst>
          </p:nvPr>
        </p:nvGraphicFramePr>
        <p:xfrm>
          <a:off x="3546872" y="775736"/>
          <a:ext cx="3413483" cy="2548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3769408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68</TotalTime>
  <Words>133</Words>
  <Application>Microsoft Office PowerPoint</Application>
  <PresentationFormat>A4 Paper (210x297 mm)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tcher, Louise (Agriculture, Floreat)</dc:creator>
  <cp:lastModifiedBy>Thatcher, Louise (Agriculture, Floreat)</cp:lastModifiedBy>
  <cp:revision>137</cp:revision>
  <cp:lastPrinted>2016-06-03T09:23:52Z</cp:lastPrinted>
  <dcterms:created xsi:type="dcterms:W3CDTF">2016-01-07T06:49:03Z</dcterms:created>
  <dcterms:modified xsi:type="dcterms:W3CDTF">2016-06-11T09:24:58Z</dcterms:modified>
</cp:coreProperties>
</file>